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ciWri\P31\Phoebe\Phoebe\annotation%20summary.txt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6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Annotation Summar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6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nnotation summary'!$B$1</c:f>
              <c:strCache>
                <c:ptCount val="1"/>
                <c:pt idx="0">
                  <c:v>Number of Unigenes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'annotation summary'!$A$2:$A$8</c:f>
              <c:strCache>
                <c:ptCount val="7"/>
                <c:pt idx="0">
                  <c:v>NR</c:v>
                </c:pt>
                <c:pt idx="1">
                  <c:v>SwissProt</c:v>
                </c:pt>
                <c:pt idx="2">
                  <c:v>PFAM</c:v>
                </c:pt>
                <c:pt idx="3">
                  <c:v>GO</c:v>
                </c:pt>
                <c:pt idx="4">
                  <c:v>KO</c:v>
                </c:pt>
                <c:pt idx="5">
                  <c:v>all Databases</c:v>
                </c:pt>
                <c:pt idx="6">
                  <c:v>at least one Database</c:v>
                </c:pt>
              </c:strCache>
            </c:strRef>
          </c:cat>
          <c:val>
            <c:numRef>
              <c:f>'annotation summary'!$B$2:$B$8</c:f>
              <c:numCache>
                <c:formatCode>General</c:formatCode>
                <c:ptCount val="7"/>
                <c:pt idx="0">
                  <c:v>113841</c:v>
                </c:pt>
                <c:pt idx="1">
                  <c:v>54750</c:v>
                </c:pt>
                <c:pt idx="2">
                  <c:v>32413</c:v>
                </c:pt>
                <c:pt idx="3">
                  <c:v>3797</c:v>
                </c:pt>
                <c:pt idx="4">
                  <c:v>35226</c:v>
                </c:pt>
                <c:pt idx="5">
                  <c:v>560</c:v>
                </c:pt>
                <c:pt idx="6">
                  <c:v>118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9E-47F2-958D-0E984BD5B3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721484848"/>
        <c:axId val="721480912"/>
      </c:barChart>
      <c:catAx>
        <c:axId val="7214848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Databas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21480912"/>
        <c:crosses val="autoZero"/>
        <c:auto val="1"/>
        <c:lblAlgn val="ctr"/>
        <c:lblOffset val="100"/>
        <c:noMultiLvlLbl val="0"/>
      </c:catAx>
      <c:valAx>
        <c:axId val="721480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Number of Uni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21484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02F5D-97E3-3032-6A04-A35FFFFA5B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6195A4-D454-9C47-75D2-F3A649FE50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C1B597-99B6-D3E6-0C39-F64986AD1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49AED1-4F20-D688-6B6C-97F634663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5451A-5025-F7EA-ECD0-181F067DA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065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E66E3-2E1B-E6FD-CDBD-946147127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478846-0B0F-5DE0-B6ED-3DE96250D3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DF6953-0E36-0308-81DD-2C803B55E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8C8E8F-4B93-BEC0-F6B0-8E4B564FB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2C282-0B67-1B5A-E777-BE931A028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92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24F8D8-ED70-ADD4-1B9F-3E4D4D0481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B31510-3ED8-25FB-1962-829C480C1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A306BE-A438-6BA9-4F1D-6880A333C6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A29C2-7F5F-ADC3-E8EC-BE4478FEF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D965AB-576B-616F-91FD-D897E2176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694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8B4A9-9E05-A27B-654B-50E683D47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6F9DD-4D97-DC6B-C825-15557911ED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42988-606B-FE98-5012-2ADFFB571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6EAE4-3BA1-54F0-5DA5-819414F08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1D2AB-D3D5-A314-9AEA-09B4DA00F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535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8D1FA-BEC4-5238-4F1E-1AB2FEE89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C2B494-12E0-E091-F3A6-552753E758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365512-677A-9FD3-1AB3-A2495A22D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18A016-6F5D-90E7-FDE2-87F539874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41F630-F4EA-72FB-8C8F-54F288910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041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E535A1-77DE-2FC2-B6EF-A8F0475B6B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46745C-A708-AC11-1EBC-B1CF886744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9AE0FF-97B5-41F6-01BC-952364A5F8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1BECC7-1C29-0B06-833F-F2A6301EE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C52BFA-6669-9E3F-4423-8C78D7D9E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FCE35D-0414-3486-579D-8BF10844F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655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E1A1A-A253-4EC6-8429-706E92DFC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90F5A-5DBD-9198-5D27-149B842072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4EBBF6-C159-ADCC-997D-65483426E6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16612B-26F5-624F-CD2D-9D83E9F25C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E6F4A8-2B9D-6A7C-2B36-555359BBBA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7B9A0E-8107-B784-EE47-E2D396BDA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1435D4-CA68-4BEE-052A-63E36DDF1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FA7BEC-07E2-527D-609C-BAA48EEC5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660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0DE001-3D25-250B-C2D4-DB6EAD786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43B788-5408-43BB-2628-705CE264C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5E647B-58AF-536C-7211-3C458F40D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F7ED16-1E6C-745C-DE5F-767DEBDB3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5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19077E-D7F7-0332-5CF4-DF97F665F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3AA6A0-8DF1-CF46-2478-DB99BDCA2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4DDE39-4BA5-2FF0-0F69-BB90B1178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90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128DA-AFBB-3AF5-01D1-81871C007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153D2E-9888-5CEF-C53C-5A63CF78F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3AB23B-517C-27DC-F008-2E1B22EBC9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47BB33-0D9C-388D-4CED-F8833C812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0B2B9-C1D1-79ED-C740-890FC618D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C33290-F018-EEB4-89D2-9988F52EC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827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38BC1-11FC-DA32-0219-60D4CDE8E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DC7CBA-C9CD-EF7F-D07A-6C7D0E55FC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5BCBC6-3E1D-78DD-9785-C0E6F205ED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499ADC-45A7-A282-4640-BCF0E6031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32DEBC-5B02-0E8F-69AF-DBC45DCAF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F27547-DBEE-5738-CE90-766DFAD03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80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C46D9D-9C64-F7E7-D2B2-7E9EC61A5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614F87-54EB-8971-667F-07D3B887BB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E45896-483D-BD50-059F-85B961322F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0A935-89E2-4D6A-8955-3E6D3B68D0B1}" type="datetimeFigureOut">
              <a:rPr lang="en-US" smtClean="0"/>
              <a:t>7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D6C9B-1CB1-2BD7-15B6-42E8D4EEDE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0F690E-0ADB-E0A3-D446-75E75EB2ED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490C3-8B20-4FA2-8C86-AB3F9429E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0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DE1CC53-FF5D-4D87-C6A5-0486DED1E0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3948397"/>
              </p:ext>
            </p:extLst>
          </p:nvPr>
        </p:nvGraphicFramePr>
        <p:xfrm>
          <a:off x="1376336" y="693821"/>
          <a:ext cx="9117263" cy="54703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97859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f Dr. MN</dc:creator>
  <cp:lastModifiedBy>Prof Dr. MN</cp:lastModifiedBy>
  <cp:revision>2</cp:revision>
  <dcterms:created xsi:type="dcterms:W3CDTF">2022-07-17T07:59:44Z</dcterms:created>
  <dcterms:modified xsi:type="dcterms:W3CDTF">2022-07-17T08:00:31Z</dcterms:modified>
</cp:coreProperties>
</file>